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66EA9F2-448C-136B-F7E0-3B98F5DF46E6}" name="Castelijn, D.A.R. (Daan)" initials="DC" userId="S::d.castelijn@amsterdamumc.nl::a778fbc9-1fa4-47a2-a45a-82f6769d159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2" autoAdjust="0"/>
    <p:restoredTop sz="94660"/>
  </p:normalViewPr>
  <p:slideViewPr>
    <p:cSldViewPr snapToGrid="0">
      <p:cViewPr varScale="1">
        <p:scale>
          <a:sx n="72" d="100"/>
          <a:sy n="72" d="100"/>
        </p:scale>
        <p:origin x="13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stelijn, D.A.R. (Daan)" userId="a778fbc9-1fa4-47a2-a45a-82f6769d1597" providerId="ADAL" clId="{E81F6A6C-3232-4954-810F-C372E33F56C8}"/>
    <pc:docChg chg="modSld">
      <pc:chgData name="Castelijn, D.A.R. (Daan)" userId="a778fbc9-1fa4-47a2-a45a-82f6769d1597" providerId="ADAL" clId="{E81F6A6C-3232-4954-810F-C372E33F56C8}" dt="2025-05-03T20:39:04.561" v="8" actId="20577"/>
      <pc:docMkLst>
        <pc:docMk/>
      </pc:docMkLst>
      <pc:sldChg chg="modSp mod">
        <pc:chgData name="Castelijn, D.A.R. (Daan)" userId="a778fbc9-1fa4-47a2-a45a-82f6769d1597" providerId="ADAL" clId="{E81F6A6C-3232-4954-810F-C372E33F56C8}" dt="2025-05-03T20:39:04.561" v="8" actId="20577"/>
        <pc:sldMkLst>
          <pc:docMk/>
          <pc:sldMk cId="1150139374" sldId="256"/>
        </pc:sldMkLst>
        <pc:spChg chg="mod">
          <ac:chgData name="Castelijn, D.A.R. (Daan)" userId="a778fbc9-1fa4-47a2-a45a-82f6769d1597" providerId="ADAL" clId="{E81F6A6C-3232-4954-810F-C372E33F56C8}" dt="2025-05-03T20:38:19.905" v="5" actId="20577"/>
          <ac:spMkLst>
            <pc:docMk/>
            <pc:sldMk cId="1150139374" sldId="256"/>
            <ac:spMk id="5" creationId="{C6E9F12E-0BA1-E1ED-63E9-DB6CB022CB06}"/>
          </ac:spMkLst>
        </pc:spChg>
        <pc:spChg chg="mod">
          <ac:chgData name="Castelijn, D.A.R. (Daan)" userId="a778fbc9-1fa4-47a2-a45a-82f6769d1597" providerId="ADAL" clId="{E81F6A6C-3232-4954-810F-C372E33F56C8}" dt="2025-05-03T20:39:04.561" v="8" actId="20577"/>
          <ac:spMkLst>
            <pc:docMk/>
            <pc:sldMk cId="1150139374" sldId="256"/>
            <ac:spMk id="8" creationId="{BEE42E18-AFF9-5E6E-738C-62E36CFA05B7}"/>
          </ac:spMkLst>
        </pc:spChg>
        <pc:spChg chg="mod">
          <ac:chgData name="Castelijn, D.A.R. (Daan)" userId="a778fbc9-1fa4-47a2-a45a-82f6769d1597" providerId="ADAL" clId="{E81F6A6C-3232-4954-810F-C372E33F56C8}" dt="2025-05-03T20:38:03.512" v="3" actId="20577"/>
          <ac:spMkLst>
            <pc:docMk/>
            <pc:sldMk cId="1150139374" sldId="256"/>
            <ac:spMk id="22" creationId="{3F614C6D-648F-B006-3D22-1758FF5B236B}"/>
          </ac:spMkLst>
        </pc:spChg>
      </pc:sldChg>
    </pc:docChg>
  </pc:docChgLst>
  <pc:docChgLst>
    <pc:chgData name="Castelijn, D.A.R. (Daan)" userId="a778fbc9-1fa4-47a2-a45a-82f6769d1597" providerId="ADAL" clId="{78290B43-653B-41A4-B3EB-18801BE04F3C}"/>
    <pc:docChg chg="modSld">
      <pc:chgData name="Castelijn, D.A.R. (Daan)" userId="a778fbc9-1fa4-47a2-a45a-82f6769d1597" providerId="ADAL" clId="{78290B43-653B-41A4-B3EB-18801BE04F3C}" dt="2025-01-05T12:14:27.984" v="64" actId="1076"/>
      <pc:docMkLst>
        <pc:docMk/>
      </pc:docMkLst>
      <pc:sldChg chg="addSp modSp mod">
        <pc:chgData name="Castelijn, D.A.R. (Daan)" userId="a778fbc9-1fa4-47a2-a45a-82f6769d1597" providerId="ADAL" clId="{78290B43-653B-41A4-B3EB-18801BE04F3C}" dt="2025-01-05T12:12:32.634" v="23" actId="20577"/>
        <pc:sldMkLst>
          <pc:docMk/>
          <pc:sldMk cId="1150139374" sldId="256"/>
        </pc:sldMkLst>
        <pc:spChg chg="add mod">
          <ac:chgData name="Castelijn, D.A.R. (Daan)" userId="a778fbc9-1fa4-47a2-a45a-82f6769d1597" providerId="ADAL" clId="{78290B43-653B-41A4-B3EB-18801BE04F3C}" dt="2025-01-05T11:33:30.310" v="9" actId="1076"/>
          <ac:spMkLst>
            <pc:docMk/>
            <pc:sldMk cId="1150139374" sldId="256"/>
            <ac:spMk id="6" creationId="{F8E58F5D-3102-93DC-4E1A-1E06DE8A0343}"/>
          </ac:spMkLst>
        </pc:spChg>
        <pc:spChg chg="mod">
          <ac:chgData name="Castelijn, D.A.R. (Daan)" userId="a778fbc9-1fa4-47a2-a45a-82f6769d1597" providerId="ADAL" clId="{78290B43-653B-41A4-B3EB-18801BE04F3C}" dt="2025-01-05T11:33:22.686" v="7" actId="20577"/>
          <ac:spMkLst>
            <pc:docMk/>
            <pc:sldMk cId="1150139374" sldId="256"/>
            <ac:spMk id="7" creationId="{B6B81B0B-FC39-5CC6-536B-F462A89057A9}"/>
          </ac:spMkLst>
        </pc:spChg>
        <pc:spChg chg="mod">
          <ac:chgData name="Castelijn, D.A.R. (Daan)" userId="a778fbc9-1fa4-47a2-a45a-82f6769d1597" providerId="ADAL" clId="{78290B43-653B-41A4-B3EB-18801BE04F3C}" dt="2025-01-05T12:12:28.186" v="15" actId="20577"/>
          <ac:spMkLst>
            <pc:docMk/>
            <pc:sldMk cId="1150139374" sldId="256"/>
            <ac:spMk id="21" creationId="{A5DFD954-048E-72F4-9DE2-ADEF707D825E}"/>
          </ac:spMkLst>
        </pc:spChg>
        <pc:spChg chg="mod">
          <ac:chgData name="Castelijn, D.A.R. (Daan)" userId="a778fbc9-1fa4-47a2-a45a-82f6769d1597" providerId="ADAL" clId="{78290B43-653B-41A4-B3EB-18801BE04F3C}" dt="2025-01-05T12:12:32.634" v="23" actId="20577"/>
          <ac:spMkLst>
            <pc:docMk/>
            <pc:sldMk cId="1150139374" sldId="256"/>
            <ac:spMk id="22" creationId="{3F614C6D-648F-B006-3D22-1758FF5B236B}"/>
          </ac:spMkLst>
        </pc:spChg>
      </pc:sldChg>
      <pc:sldChg chg="modSp mod">
        <pc:chgData name="Castelijn, D.A.R. (Daan)" userId="a778fbc9-1fa4-47a2-a45a-82f6769d1597" providerId="ADAL" clId="{78290B43-653B-41A4-B3EB-18801BE04F3C}" dt="2025-01-05T12:14:27.984" v="64" actId="1076"/>
        <pc:sldMkLst>
          <pc:docMk/>
          <pc:sldMk cId="1463628720" sldId="257"/>
        </pc:sldMkLst>
        <pc:spChg chg="mod">
          <ac:chgData name="Castelijn, D.A.R. (Daan)" userId="a778fbc9-1fa4-47a2-a45a-82f6769d1597" providerId="ADAL" clId="{78290B43-653B-41A4-B3EB-18801BE04F3C}" dt="2025-01-05T12:13:40.714" v="47" actId="1076"/>
          <ac:spMkLst>
            <pc:docMk/>
            <pc:sldMk cId="1463628720" sldId="257"/>
            <ac:spMk id="3" creationId="{77118368-2C58-C7E1-113F-F489F7B69515}"/>
          </ac:spMkLst>
        </pc:spChg>
        <pc:spChg chg="mod">
          <ac:chgData name="Castelijn, D.A.R. (Daan)" userId="a778fbc9-1fa4-47a2-a45a-82f6769d1597" providerId="ADAL" clId="{78290B43-653B-41A4-B3EB-18801BE04F3C}" dt="2025-01-05T12:14:15.472" v="60" actId="1076"/>
          <ac:spMkLst>
            <pc:docMk/>
            <pc:sldMk cId="1463628720" sldId="257"/>
            <ac:spMk id="9" creationId="{7E19A389-D9FA-1AED-BF99-77F516864AFA}"/>
          </ac:spMkLst>
        </pc:spChg>
        <pc:spChg chg="mod">
          <ac:chgData name="Castelijn, D.A.R. (Daan)" userId="a778fbc9-1fa4-47a2-a45a-82f6769d1597" providerId="ADAL" clId="{78290B43-653B-41A4-B3EB-18801BE04F3C}" dt="2025-01-05T12:14:21.955" v="63" actId="403"/>
          <ac:spMkLst>
            <pc:docMk/>
            <pc:sldMk cId="1463628720" sldId="257"/>
            <ac:spMk id="18" creationId="{2BD0FA16-9632-1C06-4ADC-8209F2A86281}"/>
          </ac:spMkLst>
        </pc:spChg>
        <pc:spChg chg="mod">
          <ac:chgData name="Castelijn, D.A.R. (Daan)" userId="a778fbc9-1fa4-47a2-a45a-82f6769d1597" providerId="ADAL" clId="{78290B43-653B-41A4-B3EB-18801BE04F3C}" dt="2025-01-05T12:13:53.071" v="52" actId="403"/>
          <ac:spMkLst>
            <pc:docMk/>
            <pc:sldMk cId="1463628720" sldId="257"/>
            <ac:spMk id="20" creationId="{69A72D90-81E8-E266-6C12-C4FCB6C43691}"/>
          </ac:spMkLst>
        </pc:spChg>
        <pc:spChg chg="mod">
          <ac:chgData name="Castelijn, D.A.R. (Daan)" userId="a778fbc9-1fa4-47a2-a45a-82f6769d1597" providerId="ADAL" clId="{78290B43-653B-41A4-B3EB-18801BE04F3C}" dt="2025-01-05T12:13:58.321" v="55" actId="403"/>
          <ac:spMkLst>
            <pc:docMk/>
            <pc:sldMk cId="1463628720" sldId="257"/>
            <ac:spMk id="29" creationId="{A5EB9DE5-4289-1026-7116-6F12C292E3CD}"/>
          </ac:spMkLst>
        </pc:spChg>
        <pc:grpChg chg="mod">
          <ac:chgData name="Castelijn, D.A.R. (Daan)" userId="a778fbc9-1fa4-47a2-a45a-82f6769d1597" providerId="ADAL" clId="{78290B43-653B-41A4-B3EB-18801BE04F3C}" dt="2025-01-05T12:14:27.984" v="64" actId="1076"/>
          <ac:grpSpMkLst>
            <pc:docMk/>
            <pc:sldMk cId="1463628720" sldId="257"/>
            <ac:grpSpMk id="7" creationId="{AA48DC6E-D403-6C97-F1A8-C2EC5055477E}"/>
          </ac:grpSpMkLst>
        </pc:grpChg>
        <pc:cxnChg chg="mod">
          <ac:chgData name="Castelijn, D.A.R. (Daan)" userId="a778fbc9-1fa4-47a2-a45a-82f6769d1597" providerId="ADAL" clId="{78290B43-653B-41A4-B3EB-18801BE04F3C}" dt="2025-01-05T12:13:53.071" v="52" actId="403"/>
          <ac:cxnSpMkLst>
            <pc:docMk/>
            <pc:sldMk cId="1463628720" sldId="257"/>
            <ac:cxnSpMk id="22" creationId="{6F53E1D8-540A-D9D9-5281-C6C6EC3E4763}"/>
          </ac:cxnSpMkLst>
        </pc:cxnChg>
        <pc:cxnChg chg="mod">
          <ac:chgData name="Castelijn, D.A.R. (Daan)" userId="a778fbc9-1fa4-47a2-a45a-82f6769d1597" providerId="ADAL" clId="{78290B43-653B-41A4-B3EB-18801BE04F3C}" dt="2025-01-05T12:13:58.321" v="55" actId="403"/>
          <ac:cxnSpMkLst>
            <pc:docMk/>
            <pc:sldMk cId="1463628720" sldId="257"/>
            <ac:cxnSpMk id="23" creationId="{DBEA18A8-261A-9940-A588-EA58DFDE6F3A}"/>
          </ac:cxnSpMkLst>
        </pc:cxnChg>
        <pc:cxnChg chg="mod">
          <ac:chgData name="Castelijn, D.A.R. (Daan)" userId="a778fbc9-1fa4-47a2-a45a-82f6769d1597" providerId="ADAL" clId="{78290B43-653B-41A4-B3EB-18801BE04F3C}" dt="2025-01-05T12:13:53.071" v="52" actId="403"/>
          <ac:cxnSpMkLst>
            <pc:docMk/>
            <pc:sldMk cId="1463628720" sldId="257"/>
            <ac:cxnSpMk id="38" creationId="{86610B08-3C72-CD18-297C-6A423A2DC24D}"/>
          </ac:cxnSpMkLst>
        </pc:cxnChg>
        <pc:cxnChg chg="mod">
          <ac:chgData name="Castelijn, D.A.R. (Daan)" userId="a778fbc9-1fa4-47a2-a45a-82f6769d1597" providerId="ADAL" clId="{78290B43-653B-41A4-B3EB-18801BE04F3C}" dt="2025-01-05T12:13:58.321" v="55" actId="403"/>
          <ac:cxnSpMkLst>
            <pc:docMk/>
            <pc:sldMk cId="1463628720" sldId="257"/>
            <ac:cxnSpMk id="41" creationId="{8DF7EF47-D86F-9C8C-617B-C8B2B4D23119}"/>
          </ac:cxnSpMkLst>
        </pc:cxnChg>
      </pc:sldChg>
    </pc:docChg>
  </pc:docChgLst>
  <pc:docChgLst>
    <pc:chgData name="Castelijn, D.A.R. (Daan)" userId="a778fbc9-1fa4-47a2-a45a-82f6769d1597" providerId="ADAL" clId="{316D7AC1-EEEC-4A3E-A256-3255E2652F08}"/>
    <pc:docChg chg="modSld">
      <pc:chgData name="Castelijn, D.A.R. (Daan)" userId="a778fbc9-1fa4-47a2-a45a-82f6769d1597" providerId="ADAL" clId="{316D7AC1-EEEC-4A3E-A256-3255E2652F08}" dt="2025-05-17T07:12:39.144" v="3" actId="20577"/>
      <pc:docMkLst>
        <pc:docMk/>
      </pc:docMkLst>
      <pc:sldChg chg="modSp mod">
        <pc:chgData name="Castelijn, D.A.R. (Daan)" userId="a778fbc9-1fa4-47a2-a45a-82f6769d1597" providerId="ADAL" clId="{316D7AC1-EEEC-4A3E-A256-3255E2652F08}" dt="2025-05-17T07:12:39.144" v="3" actId="20577"/>
        <pc:sldMkLst>
          <pc:docMk/>
          <pc:sldMk cId="1150139374" sldId="256"/>
        </pc:sldMkLst>
        <pc:spChg chg="mod">
          <ac:chgData name="Castelijn, D.A.R. (Daan)" userId="a778fbc9-1fa4-47a2-a45a-82f6769d1597" providerId="ADAL" clId="{316D7AC1-EEEC-4A3E-A256-3255E2652F08}" dt="2025-05-17T07:12:27.419" v="1" actId="20577"/>
          <ac:spMkLst>
            <pc:docMk/>
            <pc:sldMk cId="1150139374" sldId="256"/>
            <ac:spMk id="5" creationId="{C6E9F12E-0BA1-E1ED-63E9-DB6CB022CB06}"/>
          </ac:spMkLst>
        </pc:spChg>
        <pc:spChg chg="mod">
          <ac:chgData name="Castelijn, D.A.R. (Daan)" userId="a778fbc9-1fa4-47a2-a45a-82f6769d1597" providerId="ADAL" clId="{316D7AC1-EEEC-4A3E-A256-3255E2652F08}" dt="2025-05-17T07:12:39.144" v="3" actId="20577"/>
          <ac:spMkLst>
            <pc:docMk/>
            <pc:sldMk cId="1150139374" sldId="256"/>
            <ac:spMk id="8" creationId="{BEE42E18-AFF9-5E6E-738C-62E36CFA05B7}"/>
          </ac:spMkLst>
        </pc:spChg>
      </pc:sldChg>
    </pc:docChg>
  </pc:docChgLst>
  <pc:docChgLst>
    <pc:chgData name="Castelijn, D.A.R. (Daan)" userId="a778fbc9-1fa4-47a2-a45a-82f6769d1597" providerId="ADAL" clId="{69EEF94C-1885-4992-8B9B-3E0F18B32CAD}"/>
    <pc:docChg chg="undo redo custSel modSld">
      <pc:chgData name="Castelijn, D.A.R. (Daan)" userId="a778fbc9-1fa4-47a2-a45a-82f6769d1597" providerId="ADAL" clId="{69EEF94C-1885-4992-8B9B-3E0F18B32CAD}" dt="2024-12-27T19:46:20.592" v="235" actId="1076"/>
      <pc:docMkLst>
        <pc:docMk/>
      </pc:docMkLst>
      <pc:sldChg chg="addSp delSp modSp mod">
        <pc:chgData name="Castelijn, D.A.R. (Daan)" userId="a778fbc9-1fa4-47a2-a45a-82f6769d1597" providerId="ADAL" clId="{69EEF94C-1885-4992-8B9B-3E0F18B32CAD}" dt="2024-12-27T19:46:09.426" v="233" actId="20577"/>
        <pc:sldMkLst>
          <pc:docMk/>
          <pc:sldMk cId="1150139374" sldId="256"/>
        </pc:sldMkLst>
        <pc:spChg chg="add mod">
          <ac:chgData name="Castelijn, D.A.R. (Daan)" userId="a778fbc9-1fa4-47a2-a45a-82f6769d1597" providerId="ADAL" clId="{69EEF94C-1885-4992-8B9B-3E0F18B32CAD}" dt="2024-12-27T19:46:09.426" v="233" actId="20577"/>
          <ac:spMkLst>
            <pc:docMk/>
            <pc:sldMk cId="1150139374" sldId="256"/>
            <ac:spMk id="3" creationId="{0D1CB86E-D5CE-0663-2EA1-143DF155B9D1}"/>
          </ac:spMkLst>
        </pc:spChg>
        <pc:spChg chg="mod">
          <ac:chgData name="Castelijn, D.A.R. (Daan)" userId="a778fbc9-1fa4-47a2-a45a-82f6769d1597" providerId="ADAL" clId="{69EEF94C-1885-4992-8B9B-3E0F18B32CAD}" dt="2024-12-27T19:45:59.985" v="230" actId="164"/>
          <ac:spMkLst>
            <pc:docMk/>
            <pc:sldMk cId="1150139374" sldId="256"/>
            <ac:spMk id="5" creationId="{C6E9F12E-0BA1-E1ED-63E9-DB6CB022CB06}"/>
          </ac:spMkLst>
        </pc:spChg>
        <pc:spChg chg="mod">
          <ac:chgData name="Castelijn, D.A.R. (Daan)" userId="a778fbc9-1fa4-47a2-a45a-82f6769d1597" providerId="ADAL" clId="{69EEF94C-1885-4992-8B9B-3E0F18B32CAD}" dt="2024-12-27T19:45:59.985" v="230" actId="164"/>
          <ac:spMkLst>
            <pc:docMk/>
            <pc:sldMk cId="1150139374" sldId="256"/>
            <ac:spMk id="7" creationId="{B6B81B0B-FC39-5CC6-536B-F462A89057A9}"/>
          </ac:spMkLst>
        </pc:spChg>
        <pc:spChg chg="mod">
          <ac:chgData name="Castelijn, D.A.R. (Daan)" userId="a778fbc9-1fa4-47a2-a45a-82f6769d1597" providerId="ADAL" clId="{69EEF94C-1885-4992-8B9B-3E0F18B32CAD}" dt="2024-12-27T19:45:59.985" v="230" actId="164"/>
          <ac:spMkLst>
            <pc:docMk/>
            <pc:sldMk cId="1150139374" sldId="256"/>
            <ac:spMk id="8" creationId="{BEE42E18-AFF9-5E6E-738C-62E36CFA05B7}"/>
          </ac:spMkLst>
        </pc:spChg>
        <pc:spChg chg="del">
          <ac:chgData name="Castelijn, D.A.R. (Daan)" userId="a778fbc9-1fa4-47a2-a45a-82f6769d1597" providerId="ADAL" clId="{69EEF94C-1885-4992-8B9B-3E0F18B32CAD}" dt="2024-12-27T19:45:48.493" v="228" actId="478"/>
          <ac:spMkLst>
            <pc:docMk/>
            <pc:sldMk cId="1150139374" sldId="256"/>
            <ac:spMk id="20" creationId="{B5C87745-60F0-DF89-D225-635E5F673CA2}"/>
          </ac:spMkLst>
        </pc:spChg>
        <pc:spChg chg="mod">
          <ac:chgData name="Castelijn, D.A.R. (Daan)" userId="a778fbc9-1fa4-47a2-a45a-82f6769d1597" providerId="ADAL" clId="{69EEF94C-1885-4992-8B9B-3E0F18B32CAD}" dt="2024-12-27T19:45:59.985" v="230" actId="164"/>
          <ac:spMkLst>
            <pc:docMk/>
            <pc:sldMk cId="1150139374" sldId="256"/>
            <ac:spMk id="21" creationId="{A5DFD954-048E-72F4-9DE2-ADEF707D825E}"/>
          </ac:spMkLst>
        </pc:spChg>
        <pc:spChg chg="mod">
          <ac:chgData name="Castelijn, D.A.R. (Daan)" userId="a778fbc9-1fa4-47a2-a45a-82f6769d1597" providerId="ADAL" clId="{69EEF94C-1885-4992-8B9B-3E0F18B32CAD}" dt="2024-12-27T19:45:59.985" v="230" actId="164"/>
          <ac:spMkLst>
            <pc:docMk/>
            <pc:sldMk cId="1150139374" sldId="256"/>
            <ac:spMk id="22" creationId="{3F614C6D-648F-B006-3D22-1758FF5B236B}"/>
          </ac:spMkLst>
        </pc:spChg>
        <pc:grpChg chg="add mod">
          <ac:chgData name="Castelijn, D.A.R. (Daan)" userId="a778fbc9-1fa4-47a2-a45a-82f6769d1597" providerId="ADAL" clId="{69EEF94C-1885-4992-8B9B-3E0F18B32CAD}" dt="2024-12-27T19:46:05.160" v="231" actId="1076"/>
          <ac:grpSpMkLst>
            <pc:docMk/>
            <pc:sldMk cId="1150139374" sldId="256"/>
            <ac:grpSpMk id="4" creationId="{0E9D527A-B11D-2EAC-D14C-214BB5C0BD2A}"/>
          </ac:grpSpMkLst>
        </pc:grpChg>
        <pc:cxnChg chg="mod">
          <ac:chgData name="Castelijn, D.A.R. (Daan)" userId="a778fbc9-1fa4-47a2-a45a-82f6769d1597" providerId="ADAL" clId="{69EEF94C-1885-4992-8B9B-3E0F18B32CAD}" dt="2024-12-27T19:45:59.985" v="230" actId="164"/>
          <ac:cxnSpMkLst>
            <pc:docMk/>
            <pc:sldMk cId="1150139374" sldId="256"/>
            <ac:cxnSpMk id="14" creationId="{8DC49927-6101-DA4B-8EC6-3E30B7E2C8F7}"/>
          </ac:cxnSpMkLst>
        </pc:cxnChg>
        <pc:cxnChg chg="mod">
          <ac:chgData name="Castelijn, D.A.R. (Daan)" userId="a778fbc9-1fa4-47a2-a45a-82f6769d1597" providerId="ADAL" clId="{69EEF94C-1885-4992-8B9B-3E0F18B32CAD}" dt="2024-12-27T19:45:59.985" v="230" actId="164"/>
          <ac:cxnSpMkLst>
            <pc:docMk/>
            <pc:sldMk cId="1150139374" sldId="256"/>
            <ac:cxnSpMk id="17" creationId="{91916925-58D3-1AE5-DFC6-64B9DE9AD90E}"/>
          </ac:cxnSpMkLst>
        </pc:cxnChg>
        <pc:cxnChg chg="mod">
          <ac:chgData name="Castelijn, D.A.R. (Daan)" userId="a778fbc9-1fa4-47a2-a45a-82f6769d1597" providerId="ADAL" clId="{69EEF94C-1885-4992-8B9B-3E0F18B32CAD}" dt="2024-12-27T19:45:59.985" v="230" actId="164"/>
          <ac:cxnSpMkLst>
            <pc:docMk/>
            <pc:sldMk cId="1150139374" sldId="256"/>
            <ac:cxnSpMk id="18" creationId="{2AD5B7C4-64EA-1E37-CE4F-F658A52075B5}"/>
          </ac:cxnSpMkLst>
        </pc:cxnChg>
        <pc:cxnChg chg="mod">
          <ac:chgData name="Castelijn, D.A.R. (Daan)" userId="a778fbc9-1fa4-47a2-a45a-82f6769d1597" providerId="ADAL" clId="{69EEF94C-1885-4992-8B9B-3E0F18B32CAD}" dt="2024-12-27T19:45:59.985" v="230" actId="164"/>
          <ac:cxnSpMkLst>
            <pc:docMk/>
            <pc:sldMk cId="1150139374" sldId="256"/>
            <ac:cxnSpMk id="24" creationId="{675C8C59-A797-FFA8-192B-364EEC81C0ED}"/>
          </ac:cxnSpMkLst>
        </pc:cxnChg>
        <pc:cxnChg chg="mod">
          <ac:chgData name="Castelijn, D.A.R. (Daan)" userId="a778fbc9-1fa4-47a2-a45a-82f6769d1597" providerId="ADAL" clId="{69EEF94C-1885-4992-8B9B-3E0F18B32CAD}" dt="2024-12-27T19:45:59.985" v="230" actId="164"/>
          <ac:cxnSpMkLst>
            <pc:docMk/>
            <pc:sldMk cId="1150139374" sldId="256"/>
            <ac:cxnSpMk id="25" creationId="{C0BEDBC2-6B65-5F2C-6F39-755EAF201BFE}"/>
          </ac:cxnSpMkLst>
        </pc:cxnChg>
      </pc:sldChg>
      <pc:sldChg chg="addSp modSp mod">
        <pc:chgData name="Castelijn, D.A.R. (Daan)" userId="a778fbc9-1fa4-47a2-a45a-82f6769d1597" providerId="ADAL" clId="{69EEF94C-1885-4992-8B9B-3E0F18B32CAD}" dt="2024-12-27T19:46:20.592" v="235" actId="1076"/>
        <pc:sldMkLst>
          <pc:docMk/>
          <pc:sldMk cId="1463628720" sldId="257"/>
        </pc:sldMkLst>
        <pc:spChg chg="mod">
          <ac:chgData name="Castelijn, D.A.R. (Daan)" userId="a778fbc9-1fa4-47a2-a45a-82f6769d1597" providerId="ADAL" clId="{69EEF94C-1885-4992-8B9B-3E0F18B32CAD}" dt="2024-12-27T19:46:17.150" v="234" actId="164"/>
          <ac:spMkLst>
            <pc:docMk/>
            <pc:sldMk cId="1463628720" sldId="257"/>
            <ac:spMk id="3" creationId="{77118368-2C58-C7E1-113F-F489F7B69515}"/>
          </ac:spMkLst>
        </pc:spChg>
        <pc:spChg chg="mod">
          <ac:chgData name="Castelijn, D.A.R. (Daan)" userId="a778fbc9-1fa4-47a2-a45a-82f6769d1597" providerId="ADAL" clId="{69EEF94C-1885-4992-8B9B-3E0F18B32CAD}" dt="2024-12-27T19:46:17.150" v="234" actId="164"/>
          <ac:spMkLst>
            <pc:docMk/>
            <pc:sldMk cId="1463628720" sldId="257"/>
            <ac:spMk id="9" creationId="{7E19A389-D9FA-1AED-BF99-77F516864AFA}"/>
          </ac:spMkLst>
        </pc:spChg>
        <pc:spChg chg="mod">
          <ac:chgData name="Castelijn, D.A.R. (Daan)" userId="a778fbc9-1fa4-47a2-a45a-82f6769d1597" providerId="ADAL" clId="{69EEF94C-1885-4992-8B9B-3E0F18B32CAD}" dt="2024-12-27T19:46:17.150" v="234" actId="164"/>
          <ac:spMkLst>
            <pc:docMk/>
            <pc:sldMk cId="1463628720" sldId="257"/>
            <ac:spMk id="18" creationId="{2BD0FA16-9632-1C06-4ADC-8209F2A86281}"/>
          </ac:spMkLst>
        </pc:spChg>
        <pc:spChg chg="mod">
          <ac:chgData name="Castelijn, D.A.R. (Daan)" userId="a778fbc9-1fa4-47a2-a45a-82f6769d1597" providerId="ADAL" clId="{69EEF94C-1885-4992-8B9B-3E0F18B32CAD}" dt="2024-12-27T19:46:17.150" v="234" actId="164"/>
          <ac:spMkLst>
            <pc:docMk/>
            <pc:sldMk cId="1463628720" sldId="257"/>
            <ac:spMk id="20" creationId="{69A72D90-81E8-E266-6C12-C4FCB6C43691}"/>
          </ac:spMkLst>
        </pc:spChg>
        <pc:spChg chg="mod">
          <ac:chgData name="Castelijn, D.A.R. (Daan)" userId="a778fbc9-1fa4-47a2-a45a-82f6769d1597" providerId="ADAL" clId="{69EEF94C-1885-4992-8B9B-3E0F18B32CAD}" dt="2024-12-27T19:46:17.150" v="234" actId="164"/>
          <ac:spMkLst>
            <pc:docMk/>
            <pc:sldMk cId="1463628720" sldId="257"/>
            <ac:spMk id="29" creationId="{A5EB9DE5-4289-1026-7116-6F12C292E3CD}"/>
          </ac:spMkLst>
        </pc:spChg>
        <pc:spChg chg="mod">
          <ac:chgData name="Castelijn, D.A.R. (Daan)" userId="a778fbc9-1fa4-47a2-a45a-82f6769d1597" providerId="ADAL" clId="{69EEF94C-1885-4992-8B9B-3E0F18B32CAD}" dt="2024-12-27T19:45:41.741" v="227" actId="1076"/>
          <ac:spMkLst>
            <pc:docMk/>
            <pc:sldMk cId="1463628720" sldId="257"/>
            <ac:spMk id="36" creationId="{A6D569C7-0674-ED45-FB58-05C4070CC208}"/>
          </ac:spMkLst>
        </pc:spChg>
        <pc:grpChg chg="add mod">
          <ac:chgData name="Castelijn, D.A.R. (Daan)" userId="a778fbc9-1fa4-47a2-a45a-82f6769d1597" providerId="ADAL" clId="{69EEF94C-1885-4992-8B9B-3E0F18B32CAD}" dt="2024-12-27T19:46:20.592" v="235" actId="1076"/>
          <ac:grpSpMkLst>
            <pc:docMk/>
            <pc:sldMk cId="1463628720" sldId="257"/>
            <ac:grpSpMk id="7" creationId="{AA48DC6E-D403-6C97-F1A8-C2EC5055477E}"/>
          </ac:grpSpMkLst>
        </pc:grpChg>
        <pc:cxnChg chg="mod">
          <ac:chgData name="Castelijn, D.A.R. (Daan)" userId="a778fbc9-1fa4-47a2-a45a-82f6769d1597" providerId="ADAL" clId="{69EEF94C-1885-4992-8B9B-3E0F18B32CAD}" dt="2024-12-27T19:46:17.150" v="234" actId="164"/>
          <ac:cxnSpMkLst>
            <pc:docMk/>
            <pc:sldMk cId="1463628720" sldId="257"/>
            <ac:cxnSpMk id="19" creationId="{0EA7A971-77F1-400E-0B82-5A23F5C7705F}"/>
          </ac:cxnSpMkLst>
        </pc:cxnChg>
        <pc:cxnChg chg="mod">
          <ac:chgData name="Castelijn, D.A.R. (Daan)" userId="a778fbc9-1fa4-47a2-a45a-82f6769d1597" providerId="ADAL" clId="{69EEF94C-1885-4992-8B9B-3E0F18B32CAD}" dt="2024-12-27T19:46:17.150" v="234" actId="164"/>
          <ac:cxnSpMkLst>
            <pc:docMk/>
            <pc:sldMk cId="1463628720" sldId="257"/>
            <ac:cxnSpMk id="22" creationId="{6F53E1D8-540A-D9D9-5281-C6C6EC3E4763}"/>
          </ac:cxnSpMkLst>
        </pc:cxnChg>
        <pc:cxnChg chg="mod">
          <ac:chgData name="Castelijn, D.A.R. (Daan)" userId="a778fbc9-1fa4-47a2-a45a-82f6769d1597" providerId="ADAL" clId="{69EEF94C-1885-4992-8B9B-3E0F18B32CAD}" dt="2024-12-27T19:46:17.150" v="234" actId="164"/>
          <ac:cxnSpMkLst>
            <pc:docMk/>
            <pc:sldMk cId="1463628720" sldId="257"/>
            <ac:cxnSpMk id="23" creationId="{DBEA18A8-261A-9940-A588-EA58DFDE6F3A}"/>
          </ac:cxnSpMkLst>
        </pc:cxnChg>
        <pc:cxnChg chg="mod">
          <ac:chgData name="Castelijn, D.A.R. (Daan)" userId="a778fbc9-1fa4-47a2-a45a-82f6769d1597" providerId="ADAL" clId="{69EEF94C-1885-4992-8B9B-3E0F18B32CAD}" dt="2024-12-27T19:46:17.150" v="234" actId="164"/>
          <ac:cxnSpMkLst>
            <pc:docMk/>
            <pc:sldMk cId="1463628720" sldId="257"/>
            <ac:cxnSpMk id="38" creationId="{86610B08-3C72-CD18-297C-6A423A2DC24D}"/>
          </ac:cxnSpMkLst>
        </pc:cxnChg>
        <pc:cxnChg chg="mod">
          <ac:chgData name="Castelijn, D.A.R. (Daan)" userId="a778fbc9-1fa4-47a2-a45a-82f6769d1597" providerId="ADAL" clId="{69EEF94C-1885-4992-8B9B-3E0F18B32CAD}" dt="2024-12-27T19:46:17.150" v="234" actId="164"/>
          <ac:cxnSpMkLst>
            <pc:docMk/>
            <pc:sldMk cId="1463628720" sldId="257"/>
            <ac:cxnSpMk id="41" creationId="{8DF7EF47-D86F-9C8C-617B-C8B2B4D23119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nl-NL"/>
              <a:t>Klikken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A4E4-E9AB-44B8-A2A6-A08ACA1D17ED}" type="datetimeFigureOut">
              <a:rPr lang="nl-NL" smtClean="0"/>
              <a:t>17-5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DD51F-CA12-42CC-9118-E95B993397F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01341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A4E4-E9AB-44B8-A2A6-A08ACA1D17ED}" type="datetimeFigureOut">
              <a:rPr lang="nl-NL" smtClean="0"/>
              <a:t>17-5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DD51F-CA12-42CC-9118-E95B993397F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4388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A4E4-E9AB-44B8-A2A6-A08ACA1D17ED}" type="datetimeFigureOut">
              <a:rPr lang="nl-NL" smtClean="0"/>
              <a:t>17-5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DD51F-CA12-42CC-9118-E95B993397F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0066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A4E4-E9AB-44B8-A2A6-A08ACA1D17ED}" type="datetimeFigureOut">
              <a:rPr lang="nl-NL" smtClean="0"/>
              <a:t>17-5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DD51F-CA12-42CC-9118-E95B993397F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78949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A4E4-E9AB-44B8-A2A6-A08ACA1D17ED}" type="datetimeFigureOut">
              <a:rPr lang="nl-NL" smtClean="0"/>
              <a:t>17-5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DD51F-CA12-42CC-9118-E95B993397F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65784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A4E4-E9AB-44B8-A2A6-A08ACA1D17ED}" type="datetimeFigureOut">
              <a:rPr lang="nl-NL" smtClean="0"/>
              <a:t>17-5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DD51F-CA12-42CC-9118-E95B993397F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71478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A4E4-E9AB-44B8-A2A6-A08ACA1D17ED}" type="datetimeFigureOut">
              <a:rPr lang="nl-NL" smtClean="0"/>
              <a:t>17-5-2025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DD51F-CA12-42CC-9118-E95B993397F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13432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A4E4-E9AB-44B8-A2A6-A08ACA1D17ED}" type="datetimeFigureOut">
              <a:rPr lang="nl-NL" smtClean="0"/>
              <a:t>17-5-2025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DD51F-CA12-42CC-9118-E95B993397F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599597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A4E4-E9AB-44B8-A2A6-A08ACA1D17ED}" type="datetimeFigureOut">
              <a:rPr lang="nl-NL" smtClean="0"/>
              <a:t>17-5-2025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DD51F-CA12-42CC-9118-E95B993397F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96580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A4E4-E9AB-44B8-A2A6-A08ACA1D17ED}" type="datetimeFigureOut">
              <a:rPr lang="nl-NL" smtClean="0"/>
              <a:t>17-5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DD51F-CA12-42CC-9118-E95B993397F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33209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nl-NL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BA4E4-E9AB-44B8-A2A6-A08ACA1D17ED}" type="datetimeFigureOut">
              <a:rPr lang="nl-NL" smtClean="0"/>
              <a:t>17-5-2025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DD51F-CA12-42CC-9118-E95B993397F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59691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9BA4E4-E9AB-44B8-A2A6-A08ACA1D17ED}" type="datetimeFigureOut">
              <a:rPr lang="nl-NL" smtClean="0"/>
              <a:t>17-5-2025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EDD51F-CA12-42CC-9118-E95B993397F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300958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ep 3">
            <a:extLst>
              <a:ext uri="{FF2B5EF4-FFF2-40B4-BE49-F238E27FC236}">
                <a16:creationId xmlns:a16="http://schemas.microsoft.com/office/drawing/2014/main" id="{0E9D527A-B11D-2EAC-D14C-214BB5C0BD2A}"/>
              </a:ext>
            </a:extLst>
          </p:cNvPr>
          <p:cNvGrpSpPr/>
          <p:nvPr/>
        </p:nvGrpSpPr>
        <p:grpSpPr>
          <a:xfrm>
            <a:off x="620976" y="822257"/>
            <a:ext cx="3998192" cy="3792186"/>
            <a:chOff x="617690" y="534023"/>
            <a:chExt cx="3998192" cy="3792186"/>
          </a:xfrm>
        </p:grpSpPr>
        <p:sp>
          <p:nvSpPr>
            <p:cNvPr id="5" name="Tekstvak 4">
              <a:extLst>
                <a:ext uri="{FF2B5EF4-FFF2-40B4-BE49-F238E27FC236}">
                  <a16:creationId xmlns:a16="http://schemas.microsoft.com/office/drawing/2014/main" id="{C6E9F12E-0BA1-E1ED-63E9-DB6CB022CB06}"/>
                </a:ext>
              </a:extLst>
            </p:cNvPr>
            <p:cNvSpPr txBox="1"/>
            <p:nvPr/>
          </p:nvSpPr>
          <p:spPr>
            <a:xfrm>
              <a:off x="1048752" y="1427228"/>
              <a:ext cx="2373767" cy="4616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HLA-DQ2.5</a:t>
              </a:r>
              <a:r>
                <a:rPr lang="en-US" sz="1200" baseline="30000" dirty="0"/>
                <a:t>+</a:t>
              </a:r>
              <a:r>
                <a:rPr lang="en-US" sz="1200" dirty="0"/>
                <a:t> patients n=35, </a:t>
              </a:r>
            </a:p>
            <a:p>
              <a:pPr algn="ctr"/>
              <a:r>
                <a:rPr lang="en-US" sz="1200" dirty="0"/>
                <a:t>HLA-DQ2.5</a:t>
              </a:r>
              <a:r>
                <a:rPr lang="en-US" sz="1200" baseline="30000" dirty="0"/>
                <a:t>+</a:t>
              </a:r>
              <a:r>
                <a:rPr lang="en-US" sz="1200" dirty="0"/>
                <a:t> HC, n=18</a:t>
              </a:r>
            </a:p>
          </p:txBody>
        </p:sp>
        <p:sp>
          <p:nvSpPr>
            <p:cNvPr id="7" name="Tekstvak 6">
              <a:extLst>
                <a:ext uri="{FF2B5EF4-FFF2-40B4-BE49-F238E27FC236}">
                  <a16:creationId xmlns:a16="http://schemas.microsoft.com/office/drawing/2014/main" id="{B6B81B0B-FC39-5CC6-536B-F462A89057A9}"/>
                </a:ext>
              </a:extLst>
            </p:cNvPr>
            <p:cNvSpPr txBox="1"/>
            <p:nvPr/>
          </p:nvSpPr>
          <p:spPr>
            <a:xfrm>
              <a:off x="2379785" y="2212617"/>
              <a:ext cx="2236097" cy="10156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Exclusions: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200" dirty="0"/>
                <a:t>&lt; 1x10</a:t>
              </a:r>
              <a:r>
                <a:rPr lang="en-US" sz="1200" baseline="30000" dirty="0"/>
                <a:t>6</a:t>
              </a:r>
              <a:r>
                <a:rPr lang="en-US" sz="1200" dirty="0"/>
                <a:t> CD4</a:t>
              </a:r>
              <a:r>
                <a:rPr lang="en-US" sz="1200" baseline="30000" dirty="0"/>
                <a:t>+</a:t>
              </a:r>
              <a:r>
                <a:rPr lang="en-US" sz="1200" dirty="0"/>
                <a:t> cells and/or &lt;80x10</a:t>
              </a:r>
              <a:r>
                <a:rPr lang="en-US" sz="1200" baseline="30000" dirty="0"/>
                <a:t>3</a:t>
              </a:r>
              <a:r>
                <a:rPr lang="en-US" sz="1200" dirty="0"/>
                <a:t> T</a:t>
              </a:r>
              <a:r>
                <a:rPr lang="en-US" sz="1200" baseline="-25000" dirty="0"/>
                <a:t>EM</a:t>
              </a:r>
              <a:r>
                <a:rPr lang="en-US" sz="1200" dirty="0"/>
                <a:t> analyzed*, n=3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200" dirty="0"/>
                <a:t>Background too high, n=2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200" dirty="0"/>
                <a:t>HC, tTG-IgA positive, n=2</a:t>
              </a:r>
            </a:p>
          </p:txBody>
        </p:sp>
        <p:sp>
          <p:nvSpPr>
            <p:cNvPr id="8" name="Tekstvak 7">
              <a:extLst>
                <a:ext uri="{FF2B5EF4-FFF2-40B4-BE49-F238E27FC236}">
                  <a16:creationId xmlns:a16="http://schemas.microsoft.com/office/drawing/2014/main" id="{BEE42E18-AFF9-5E6E-738C-62E36CFA05B7}"/>
                </a:ext>
              </a:extLst>
            </p:cNvPr>
            <p:cNvSpPr txBox="1"/>
            <p:nvPr/>
          </p:nvSpPr>
          <p:spPr>
            <a:xfrm>
              <a:off x="658203" y="3310546"/>
              <a:ext cx="1433220" cy="10156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Inclusions:</a:t>
              </a:r>
            </a:p>
            <a:p>
              <a:pPr algn="r"/>
              <a:r>
                <a:rPr lang="en-US" sz="1200" dirty="0"/>
                <a:t>HC, n=18</a:t>
              </a:r>
            </a:p>
            <a:p>
              <a:pPr algn="r"/>
              <a:r>
                <a:rPr lang="en-US" sz="1200" dirty="0"/>
                <a:t>NCGS, n=9</a:t>
              </a:r>
            </a:p>
            <a:p>
              <a:pPr algn="r"/>
              <a:r>
                <a:rPr lang="en-US" sz="1200" dirty="0"/>
                <a:t>Active CD, n=7</a:t>
              </a:r>
            </a:p>
            <a:p>
              <a:pPr algn="r"/>
              <a:r>
                <a:rPr lang="en-US" sz="1200" dirty="0"/>
                <a:t>CD on GFD, n=14</a:t>
              </a:r>
            </a:p>
          </p:txBody>
        </p:sp>
        <p:cxnSp>
          <p:nvCxnSpPr>
            <p:cNvPr id="14" name="Rechte verbindingslijn 13">
              <a:extLst>
                <a:ext uri="{FF2B5EF4-FFF2-40B4-BE49-F238E27FC236}">
                  <a16:creationId xmlns:a16="http://schemas.microsoft.com/office/drawing/2014/main" id="{8DC49927-6101-DA4B-8EC6-3E30B7E2C8F7}"/>
                </a:ext>
              </a:extLst>
            </p:cNvPr>
            <p:cNvCxnSpPr>
              <a:cxnSpLocks/>
            </p:cNvCxnSpPr>
            <p:nvPr/>
          </p:nvCxnSpPr>
          <p:spPr>
            <a:xfrm>
              <a:off x="2242116" y="1909012"/>
              <a:ext cx="0" cy="1944000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Rechte verbindingslijn 16">
              <a:extLst>
                <a:ext uri="{FF2B5EF4-FFF2-40B4-BE49-F238E27FC236}">
                  <a16:creationId xmlns:a16="http://schemas.microsoft.com/office/drawing/2014/main" id="{91916925-58D3-1AE5-DFC6-64B9DE9AD90E}"/>
                </a:ext>
              </a:extLst>
            </p:cNvPr>
            <p:cNvCxnSpPr/>
            <p:nvPr/>
          </p:nvCxnSpPr>
          <p:spPr>
            <a:xfrm flipH="1">
              <a:off x="2242116" y="2720448"/>
              <a:ext cx="13766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Rechte verbindingslijn 17">
              <a:extLst>
                <a:ext uri="{FF2B5EF4-FFF2-40B4-BE49-F238E27FC236}">
                  <a16:creationId xmlns:a16="http://schemas.microsoft.com/office/drawing/2014/main" id="{2AD5B7C4-64EA-1E37-CE4F-F658A52075B5}"/>
                </a:ext>
              </a:extLst>
            </p:cNvPr>
            <p:cNvCxnSpPr/>
            <p:nvPr/>
          </p:nvCxnSpPr>
          <p:spPr>
            <a:xfrm flipH="1">
              <a:off x="2097935" y="3842566"/>
              <a:ext cx="13766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kstvak 20">
              <a:extLst>
                <a:ext uri="{FF2B5EF4-FFF2-40B4-BE49-F238E27FC236}">
                  <a16:creationId xmlns:a16="http://schemas.microsoft.com/office/drawing/2014/main" id="{A5DFD954-048E-72F4-9DE2-ADEF707D825E}"/>
                </a:ext>
              </a:extLst>
            </p:cNvPr>
            <p:cNvSpPr txBox="1"/>
            <p:nvPr/>
          </p:nvSpPr>
          <p:spPr>
            <a:xfrm>
              <a:off x="617690" y="535476"/>
              <a:ext cx="1602561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dult (suspected) CD patients screened for HLA-DQ2.5, n=37 </a:t>
              </a:r>
            </a:p>
          </p:txBody>
        </p:sp>
        <p:sp>
          <p:nvSpPr>
            <p:cNvPr id="22" name="Tekstvak 21">
              <a:extLst>
                <a:ext uri="{FF2B5EF4-FFF2-40B4-BE49-F238E27FC236}">
                  <a16:creationId xmlns:a16="http://schemas.microsoft.com/office/drawing/2014/main" id="{3F614C6D-648F-B006-3D22-1758FF5B236B}"/>
                </a:ext>
              </a:extLst>
            </p:cNvPr>
            <p:cNvSpPr txBox="1"/>
            <p:nvPr/>
          </p:nvSpPr>
          <p:spPr>
            <a:xfrm>
              <a:off x="2398781" y="534023"/>
              <a:ext cx="1602561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dult healthy controls (HC) screened for </a:t>
              </a:r>
            </a:p>
            <a:p>
              <a:pPr algn="ctr"/>
              <a:r>
                <a:rPr lang="en-US" sz="1200" dirty="0"/>
                <a:t>HLA-DQ2.5, n=94</a:t>
              </a:r>
            </a:p>
          </p:txBody>
        </p:sp>
        <p:cxnSp>
          <p:nvCxnSpPr>
            <p:cNvPr id="24" name="Rechte verbindingslijn 23">
              <a:extLst>
                <a:ext uri="{FF2B5EF4-FFF2-40B4-BE49-F238E27FC236}">
                  <a16:creationId xmlns:a16="http://schemas.microsoft.com/office/drawing/2014/main" id="{675C8C59-A797-FFA8-192B-364EEC81C0ED}"/>
                </a:ext>
              </a:extLst>
            </p:cNvPr>
            <p:cNvCxnSpPr>
              <a:stCxn id="22" idx="2"/>
            </p:cNvCxnSpPr>
            <p:nvPr/>
          </p:nvCxnSpPr>
          <p:spPr>
            <a:xfrm>
              <a:off x="3200062" y="1180354"/>
              <a:ext cx="0" cy="24617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Rechte verbindingslijn 24">
              <a:extLst>
                <a:ext uri="{FF2B5EF4-FFF2-40B4-BE49-F238E27FC236}">
                  <a16:creationId xmlns:a16="http://schemas.microsoft.com/office/drawing/2014/main" id="{C0BEDBC2-6B65-5F2C-6F39-755EAF201BFE}"/>
                </a:ext>
              </a:extLst>
            </p:cNvPr>
            <p:cNvCxnSpPr/>
            <p:nvPr/>
          </p:nvCxnSpPr>
          <p:spPr>
            <a:xfrm>
              <a:off x="1443447" y="1188376"/>
              <a:ext cx="0" cy="24617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" name="Tekstvak 2">
            <a:extLst>
              <a:ext uri="{FF2B5EF4-FFF2-40B4-BE49-F238E27FC236}">
                <a16:creationId xmlns:a16="http://schemas.microsoft.com/office/drawing/2014/main" id="{0D1CB86E-D5CE-0663-2EA1-143DF155B9D1}"/>
              </a:ext>
            </a:extLst>
          </p:cNvPr>
          <p:cNvSpPr txBox="1"/>
          <p:nvPr/>
        </p:nvSpPr>
        <p:spPr>
          <a:xfrm>
            <a:off x="208771" y="197347"/>
            <a:ext cx="2419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Supplemental Figure 1A</a:t>
            </a:r>
          </a:p>
        </p:txBody>
      </p:sp>
      <p:sp>
        <p:nvSpPr>
          <p:cNvPr id="6" name="Tekstvak 5">
            <a:extLst>
              <a:ext uri="{FF2B5EF4-FFF2-40B4-BE49-F238E27FC236}">
                <a16:creationId xmlns:a16="http://schemas.microsoft.com/office/drawing/2014/main" id="{F8E58F5D-3102-93DC-4E1A-1E06DE8A0343}"/>
              </a:ext>
            </a:extLst>
          </p:cNvPr>
          <p:cNvSpPr txBox="1"/>
          <p:nvPr/>
        </p:nvSpPr>
        <p:spPr>
          <a:xfrm>
            <a:off x="563213" y="4799667"/>
            <a:ext cx="495799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nl-NL" sz="1200" dirty="0"/>
              <a:t>*</a:t>
            </a:r>
            <a:r>
              <a:rPr lang="nl-NL" sz="1200" dirty="0" err="1"/>
              <a:t>Based</a:t>
            </a:r>
            <a:r>
              <a:rPr lang="nl-NL" sz="1200" dirty="0"/>
              <a:t> on the </a:t>
            </a:r>
            <a:r>
              <a:rPr lang="nl-NL" sz="1200" dirty="0" err="1"/>
              <a:t>expected</a:t>
            </a:r>
            <a:r>
              <a:rPr lang="nl-NL" sz="1200" dirty="0"/>
              <a:t> low </a:t>
            </a:r>
            <a:r>
              <a:rPr lang="nl-NL" sz="1200" dirty="0" err="1"/>
              <a:t>frequency</a:t>
            </a:r>
            <a:r>
              <a:rPr lang="nl-NL" sz="1200" dirty="0"/>
              <a:t> of gliadin-specific T-cells</a:t>
            </a:r>
          </a:p>
        </p:txBody>
      </p:sp>
    </p:spTree>
    <p:extLst>
      <p:ext uri="{BB962C8B-B14F-4D97-AF65-F5344CB8AC3E}">
        <p14:creationId xmlns:p14="http://schemas.microsoft.com/office/powerpoint/2010/main" val="11501393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kstvak 35">
            <a:extLst>
              <a:ext uri="{FF2B5EF4-FFF2-40B4-BE49-F238E27FC236}">
                <a16:creationId xmlns:a16="http://schemas.microsoft.com/office/drawing/2014/main" id="{A6D569C7-0674-ED45-FB58-05C4070CC208}"/>
              </a:ext>
            </a:extLst>
          </p:cNvPr>
          <p:cNvSpPr txBox="1"/>
          <p:nvPr/>
        </p:nvSpPr>
        <p:spPr>
          <a:xfrm>
            <a:off x="208771" y="197347"/>
            <a:ext cx="24113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dirty="0"/>
              <a:t>Supplemental Figure 1B</a:t>
            </a:r>
          </a:p>
        </p:txBody>
      </p:sp>
      <p:grpSp>
        <p:nvGrpSpPr>
          <p:cNvPr id="7" name="Groep 6">
            <a:extLst>
              <a:ext uri="{FF2B5EF4-FFF2-40B4-BE49-F238E27FC236}">
                <a16:creationId xmlns:a16="http://schemas.microsoft.com/office/drawing/2014/main" id="{AA48DC6E-D403-6C97-F1A8-C2EC5055477E}"/>
              </a:ext>
            </a:extLst>
          </p:cNvPr>
          <p:cNvGrpSpPr/>
          <p:nvPr/>
        </p:nvGrpSpPr>
        <p:grpSpPr>
          <a:xfrm>
            <a:off x="409908" y="1022520"/>
            <a:ext cx="4420327" cy="3070717"/>
            <a:chOff x="1148003" y="1285173"/>
            <a:chExt cx="4420327" cy="3070717"/>
          </a:xfrm>
        </p:grpSpPr>
        <p:sp>
          <p:nvSpPr>
            <p:cNvPr id="3" name="Tekstvak 2">
              <a:extLst>
                <a:ext uri="{FF2B5EF4-FFF2-40B4-BE49-F238E27FC236}">
                  <a16:creationId xmlns:a16="http://schemas.microsoft.com/office/drawing/2014/main" id="{77118368-2C58-C7E1-113F-F489F7B69515}"/>
                </a:ext>
              </a:extLst>
            </p:cNvPr>
            <p:cNvSpPr txBox="1"/>
            <p:nvPr/>
          </p:nvSpPr>
          <p:spPr>
            <a:xfrm>
              <a:off x="1605722" y="1285173"/>
              <a:ext cx="3361481" cy="4616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Adult CD patients on GFD &gt; 5 years, HLA-DQ2.5</a:t>
              </a:r>
              <a:r>
                <a:rPr lang="en-US" sz="1200" baseline="30000" dirty="0"/>
                <a:t>+</a:t>
              </a:r>
              <a:r>
                <a:rPr lang="en-US" sz="1200" dirty="0"/>
                <a:t>  n=8</a:t>
              </a:r>
            </a:p>
          </p:txBody>
        </p:sp>
        <p:sp>
          <p:nvSpPr>
            <p:cNvPr id="20" name="Tekstvak 19">
              <a:extLst>
                <a:ext uri="{FF2B5EF4-FFF2-40B4-BE49-F238E27FC236}">
                  <a16:creationId xmlns:a16="http://schemas.microsoft.com/office/drawing/2014/main" id="{69A72D90-81E8-E266-6C12-C4FCB6C43691}"/>
                </a:ext>
              </a:extLst>
            </p:cNvPr>
            <p:cNvSpPr txBox="1"/>
            <p:nvPr/>
          </p:nvSpPr>
          <p:spPr>
            <a:xfrm>
              <a:off x="1496099" y="1986935"/>
              <a:ext cx="1471631" cy="4616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5 g gluten/day</a:t>
              </a:r>
            </a:p>
            <a:p>
              <a:pPr algn="ctr"/>
              <a:r>
                <a:rPr lang="en-US" sz="1200" dirty="0"/>
                <a:t>n=3</a:t>
              </a:r>
            </a:p>
          </p:txBody>
        </p:sp>
        <p:cxnSp>
          <p:nvCxnSpPr>
            <p:cNvPr id="22" name="Rechte verbindingslijn 21">
              <a:extLst>
                <a:ext uri="{FF2B5EF4-FFF2-40B4-BE49-F238E27FC236}">
                  <a16:creationId xmlns:a16="http://schemas.microsoft.com/office/drawing/2014/main" id="{6F53E1D8-540A-D9D9-5281-C6C6EC3E4763}"/>
                </a:ext>
              </a:extLst>
            </p:cNvPr>
            <p:cNvCxnSpPr>
              <a:cxnSpLocks/>
              <a:stCxn id="3" idx="2"/>
              <a:endCxn id="20" idx="0"/>
            </p:cNvCxnSpPr>
            <p:nvPr/>
          </p:nvCxnSpPr>
          <p:spPr>
            <a:xfrm flipH="1">
              <a:off x="2231915" y="1746838"/>
              <a:ext cx="1054548" cy="24009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Rechte verbindingslijn 22">
              <a:extLst>
                <a:ext uri="{FF2B5EF4-FFF2-40B4-BE49-F238E27FC236}">
                  <a16:creationId xmlns:a16="http://schemas.microsoft.com/office/drawing/2014/main" id="{DBEA18A8-261A-9940-A588-EA58DFDE6F3A}"/>
                </a:ext>
              </a:extLst>
            </p:cNvPr>
            <p:cNvCxnSpPr>
              <a:cxnSpLocks/>
              <a:stCxn id="3" idx="2"/>
              <a:endCxn id="29" idx="0"/>
            </p:cNvCxnSpPr>
            <p:nvPr/>
          </p:nvCxnSpPr>
          <p:spPr>
            <a:xfrm>
              <a:off x="3286463" y="1746838"/>
              <a:ext cx="1002778" cy="24009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" name="Tekstvak 28">
              <a:extLst>
                <a:ext uri="{FF2B5EF4-FFF2-40B4-BE49-F238E27FC236}">
                  <a16:creationId xmlns:a16="http://schemas.microsoft.com/office/drawing/2014/main" id="{A5EB9DE5-4289-1026-7116-6F12C292E3CD}"/>
                </a:ext>
              </a:extLst>
            </p:cNvPr>
            <p:cNvSpPr txBox="1"/>
            <p:nvPr/>
          </p:nvSpPr>
          <p:spPr>
            <a:xfrm>
              <a:off x="3553425" y="1986935"/>
              <a:ext cx="1471631" cy="4616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15 g gluten/day</a:t>
              </a:r>
            </a:p>
            <a:p>
              <a:pPr algn="ctr"/>
              <a:r>
                <a:rPr lang="en-US" sz="1200" dirty="0"/>
                <a:t>n=5</a:t>
              </a:r>
            </a:p>
          </p:txBody>
        </p:sp>
        <p:cxnSp>
          <p:nvCxnSpPr>
            <p:cNvPr id="38" name="Rechte verbindingslijn 37">
              <a:extLst>
                <a:ext uri="{FF2B5EF4-FFF2-40B4-BE49-F238E27FC236}">
                  <a16:creationId xmlns:a16="http://schemas.microsoft.com/office/drawing/2014/main" id="{86610B08-3C72-CD18-297C-6A423A2DC24D}"/>
                </a:ext>
              </a:extLst>
            </p:cNvPr>
            <p:cNvCxnSpPr>
              <a:cxnSpLocks/>
              <a:stCxn id="20" idx="2"/>
            </p:cNvCxnSpPr>
            <p:nvPr/>
          </p:nvCxnSpPr>
          <p:spPr>
            <a:xfrm flipH="1">
              <a:off x="2231914" y="2448600"/>
              <a:ext cx="1" cy="2984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Rechte verbindingslijn 40">
              <a:extLst>
                <a:ext uri="{FF2B5EF4-FFF2-40B4-BE49-F238E27FC236}">
                  <a16:creationId xmlns:a16="http://schemas.microsoft.com/office/drawing/2014/main" id="{8DF7EF47-D86F-9C8C-617B-C8B2B4D23119}"/>
                </a:ext>
              </a:extLst>
            </p:cNvPr>
            <p:cNvCxnSpPr>
              <a:cxnSpLocks/>
              <a:stCxn id="29" idx="2"/>
            </p:cNvCxnSpPr>
            <p:nvPr/>
          </p:nvCxnSpPr>
          <p:spPr>
            <a:xfrm flipH="1">
              <a:off x="4289240" y="2448600"/>
              <a:ext cx="1" cy="29844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kstvak 8">
              <a:extLst>
                <a:ext uri="{FF2B5EF4-FFF2-40B4-BE49-F238E27FC236}">
                  <a16:creationId xmlns:a16="http://schemas.microsoft.com/office/drawing/2014/main" id="{7E19A389-D9FA-1AED-BF99-77F516864AFA}"/>
                </a:ext>
              </a:extLst>
            </p:cNvPr>
            <p:cNvSpPr txBox="1"/>
            <p:nvPr/>
          </p:nvSpPr>
          <p:spPr>
            <a:xfrm>
              <a:off x="1148003" y="2745704"/>
              <a:ext cx="4420327" cy="2769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Weekly analysis of </a:t>
              </a:r>
              <a:r>
                <a:rPr lang="el-GR" sz="1200" dirty="0"/>
                <a:t>α-</a:t>
              </a:r>
              <a:r>
                <a:rPr lang="en-US" sz="1200" dirty="0" err="1"/>
                <a:t>gliadin-Dm:CLIP-Dm</a:t>
              </a:r>
              <a:r>
                <a:rPr lang="en-US" sz="1200" dirty="0"/>
                <a:t> ratio and CD38 expression</a:t>
              </a:r>
            </a:p>
          </p:txBody>
        </p:sp>
        <p:sp>
          <p:nvSpPr>
            <p:cNvPr id="18" name="Tekstvak 17">
              <a:extLst>
                <a:ext uri="{FF2B5EF4-FFF2-40B4-BE49-F238E27FC236}">
                  <a16:creationId xmlns:a16="http://schemas.microsoft.com/office/drawing/2014/main" id="{2BD0FA16-9632-1C06-4ADC-8209F2A86281}"/>
                </a:ext>
              </a:extLst>
            </p:cNvPr>
            <p:cNvSpPr txBox="1"/>
            <p:nvPr/>
          </p:nvSpPr>
          <p:spPr>
            <a:xfrm>
              <a:off x="1421367" y="3371005"/>
              <a:ext cx="3880545" cy="984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End of study after meeting one or two study endpoints:</a:t>
              </a:r>
            </a:p>
            <a:p>
              <a:pPr marL="285750" indent="-285750">
                <a:buFontTx/>
                <a:buChar char="-"/>
              </a:pPr>
              <a:r>
                <a:rPr lang="en-US" sz="1200" dirty="0"/>
                <a:t>Doubling of </a:t>
              </a:r>
              <a:r>
                <a:rPr lang="el-GR" sz="1200" dirty="0"/>
                <a:t>α-</a:t>
              </a:r>
              <a:r>
                <a:rPr lang="en-US" sz="1200" dirty="0" err="1"/>
                <a:t>gliadin-Dm:CLIP-Dm</a:t>
              </a:r>
              <a:r>
                <a:rPr lang="en-US" sz="1200" dirty="0"/>
                <a:t> ratio   </a:t>
              </a:r>
              <a:r>
                <a:rPr lang="en-US" sz="1200" i="1" dirty="0"/>
                <a:t>   </a:t>
              </a:r>
            </a:p>
            <a:p>
              <a:pPr marL="285750" indent="-285750">
                <a:buFontTx/>
                <a:buChar char="-"/>
              </a:pPr>
              <a:r>
                <a:rPr lang="en-US" sz="1200" dirty="0"/>
                <a:t>Elevated baseline ratio AND significant increase of CD38 expression on </a:t>
              </a:r>
              <a:r>
                <a:rPr lang="nl-NL" sz="1200" dirty="0" err="1"/>
                <a:t>gliadin-specific</a:t>
              </a:r>
              <a:r>
                <a:rPr lang="nl-NL" sz="1200" dirty="0"/>
                <a:t> </a:t>
              </a:r>
              <a:r>
                <a:rPr lang="nl-NL" sz="1200" dirty="0" err="1"/>
                <a:t>T-cells</a:t>
              </a:r>
              <a:endParaRPr lang="en-NL" sz="1200" dirty="0"/>
            </a:p>
            <a:p>
              <a:endParaRPr lang="nl-NL" sz="1000" dirty="0"/>
            </a:p>
          </p:txBody>
        </p:sp>
        <p:cxnSp>
          <p:nvCxnSpPr>
            <p:cNvPr id="19" name="Rechte verbindingslijn 18">
              <a:extLst>
                <a:ext uri="{FF2B5EF4-FFF2-40B4-BE49-F238E27FC236}">
                  <a16:creationId xmlns:a16="http://schemas.microsoft.com/office/drawing/2014/main" id="{0EA7A971-77F1-400E-0B82-5A23F5C7705F}"/>
                </a:ext>
              </a:extLst>
            </p:cNvPr>
            <p:cNvCxnSpPr/>
            <p:nvPr/>
          </p:nvCxnSpPr>
          <p:spPr>
            <a:xfrm>
              <a:off x="3286463" y="3011034"/>
              <a:ext cx="0" cy="35997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63628720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67</TotalTime>
  <Words>185</Words>
  <Application>Microsoft Office PowerPoint</Application>
  <PresentationFormat>A4 (210 x 297 mm)</PresentationFormat>
  <Paragraphs>26</Paragraphs>
  <Slides>2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Kantoorthema</vt:lpstr>
      <vt:lpstr>PowerPoint-presentatie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Bontkes, H.J. (Hetty)</dc:creator>
  <cp:lastModifiedBy>Castelijn, D.A.R. (Daan)</cp:lastModifiedBy>
  <cp:revision>3</cp:revision>
  <dcterms:created xsi:type="dcterms:W3CDTF">2024-12-05T12:10:27Z</dcterms:created>
  <dcterms:modified xsi:type="dcterms:W3CDTF">2025-05-17T07:12:41Z</dcterms:modified>
</cp:coreProperties>
</file>